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04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A53195D-B87B-456E-B822-17D006E08CA9}" v="6" dt="2020-03-29T19:39:36.4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D:\users\336083\Documents\&#19968;&#26178;&#20445;&#31649;\191227_&#12487;&#12473;&#12463;&#12488;&#12483;&#12503;&#12501;&#12457;&#12523;&#12480;\ST&#21092;&#35542;&#25991;\191023&#25913;_190410%20ST&#21092;&#38263;&#26399;&#35430;&#39443;%20Skindex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bar"/>
        <c:grouping val="percentStacked"/>
        <c:varyColors val="0"/>
        <c:ser>
          <c:idx val="0"/>
          <c:order val="0"/>
          <c:tx>
            <c:strRef>
              <c:f>アンケート!$C$3</c:f>
              <c:strCache>
                <c:ptCount val="1"/>
                <c:pt idx="0">
                  <c:v>Agreed</c:v>
                </c:pt>
              </c:strCache>
            </c:strRef>
          </c:tx>
          <c:invertIfNegative val="0"/>
          <c:cat>
            <c:strRef>
              <c:f>アンケート!$B$4:$B$11</c:f>
              <c:strCache>
                <c:ptCount val="8"/>
                <c:pt idx="0">
                  <c:v>Want to continue using them</c:v>
                </c:pt>
                <c:pt idx="1">
                  <c:v>Benefit me</c:v>
                </c:pt>
                <c:pt idx="2">
                  <c:v>Affected area becomes inconspicuous</c:v>
                </c:pt>
                <c:pt idx="3">
                  <c:v>Formed color lasts</c:v>
                </c:pt>
                <c:pt idx="4">
                  <c:v>Skin color changes gradually</c:v>
                </c:pt>
                <c:pt idx="5">
                  <c:v>Free from load on the skin</c:v>
                </c:pt>
                <c:pt idx="6">
                  <c:v>Compatible with the skin</c:v>
                </c:pt>
                <c:pt idx="7">
                  <c:v>Soft to the touch</c:v>
                </c:pt>
              </c:strCache>
            </c:strRef>
          </c:cat>
          <c:val>
            <c:numRef>
              <c:f>アンケート!$C$4:$C$11</c:f>
              <c:numCache>
                <c:formatCode>General</c:formatCode>
                <c:ptCount val="8"/>
                <c:pt idx="0">
                  <c:v>4</c:v>
                </c:pt>
                <c:pt idx="1">
                  <c:v>4</c:v>
                </c:pt>
                <c:pt idx="2">
                  <c:v>3</c:v>
                </c:pt>
                <c:pt idx="3">
                  <c:v>2</c:v>
                </c:pt>
                <c:pt idx="4">
                  <c:v>3</c:v>
                </c:pt>
                <c:pt idx="5">
                  <c:v>3</c:v>
                </c:pt>
                <c:pt idx="6">
                  <c:v>4</c:v>
                </c:pt>
                <c:pt idx="7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4EB-447E-8904-F0E07FEC51A0}"/>
            </c:ext>
          </c:extLst>
        </c:ser>
        <c:ser>
          <c:idx val="1"/>
          <c:order val="1"/>
          <c:tx>
            <c:strRef>
              <c:f>アンケート!$D$3</c:f>
              <c:strCache>
                <c:ptCount val="1"/>
                <c:pt idx="0">
                  <c:v>Agreed somewhat</c:v>
                </c:pt>
              </c:strCache>
            </c:strRef>
          </c:tx>
          <c:invertIfNegative val="0"/>
          <c:cat>
            <c:strRef>
              <c:f>アンケート!$B$4:$B$11</c:f>
              <c:strCache>
                <c:ptCount val="8"/>
                <c:pt idx="0">
                  <c:v>Want to continue using them</c:v>
                </c:pt>
                <c:pt idx="1">
                  <c:v>Benefit me</c:v>
                </c:pt>
                <c:pt idx="2">
                  <c:v>Affected area becomes inconspicuous</c:v>
                </c:pt>
                <c:pt idx="3">
                  <c:v>Formed color lasts</c:v>
                </c:pt>
                <c:pt idx="4">
                  <c:v>Skin color changes gradually</c:v>
                </c:pt>
                <c:pt idx="5">
                  <c:v>Free from load on the skin</c:v>
                </c:pt>
                <c:pt idx="6">
                  <c:v>Compatible with the skin</c:v>
                </c:pt>
                <c:pt idx="7">
                  <c:v>Soft to the touch</c:v>
                </c:pt>
              </c:strCache>
            </c:strRef>
          </c:cat>
          <c:val>
            <c:numRef>
              <c:f>アンケート!$D$4:$D$11</c:f>
              <c:numCache>
                <c:formatCode>General</c:formatCode>
                <c:ptCount val="8"/>
                <c:pt idx="0">
                  <c:v>3</c:v>
                </c:pt>
                <c:pt idx="1">
                  <c:v>3</c:v>
                </c:pt>
                <c:pt idx="2">
                  <c:v>4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4</c:v>
                </c:pt>
                <c:pt idx="7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4EB-447E-8904-F0E07FEC51A0}"/>
            </c:ext>
          </c:extLst>
        </c:ser>
        <c:ser>
          <c:idx val="2"/>
          <c:order val="2"/>
          <c:tx>
            <c:strRef>
              <c:f>アンケート!$E$3</c:f>
              <c:strCache>
                <c:ptCount val="1"/>
                <c:pt idx="0">
                  <c:v>Neutral</c:v>
                </c:pt>
              </c:strCache>
            </c:strRef>
          </c:tx>
          <c:invertIfNegative val="0"/>
          <c:cat>
            <c:strRef>
              <c:f>アンケート!$B$4:$B$11</c:f>
              <c:strCache>
                <c:ptCount val="8"/>
                <c:pt idx="0">
                  <c:v>Want to continue using them</c:v>
                </c:pt>
                <c:pt idx="1">
                  <c:v>Benefit me</c:v>
                </c:pt>
                <c:pt idx="2">
                  <c:v>Affected area becomes inconspicuous</c:v>
                </c:pt>
                <c:pt idx="3">
                  <c:v>Formed color lasts</c:v>
                </c:pt>
                <c:pt idx="4">
                  <c:v>Skin color changes gradually</c:v>
                </c:pt>
                <c:pt idx="5">
                  <c:v>Free from load on the skin</c:v>
                </c:pt>
                <c:pt idx="6">
                  <c:v>Compatible with the skin</c:v>
                </c:pt>
                <c:pt idx="7">
                  <c:v>Soft to the touch</c:v>
                </c:pt>
              </c:strCache>
            </c:strRef>
          </c:cat>
          <c:val>
            <c:numRef>
              <c:f>アンケート!$E$4:$E$11</c:f>
              <c:numCache>
                <c:formatCode>General</c:formatCode>
                <c:ptCount val="8"/>
                <c:pt idx="0">
                  <c:v>1</c:v>
                </c:pt>
                <c:pt idx="1">
                  <c:v>1</c:v>
                </c:pt>
                <c:pt idx="3">
                  <c:v>2</c:v>
                </c:pt>
                <c:pt idx="7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4EB-447E-8904-F0E07FEC51A0}"/>
            </c:ext>
          </c:extLst>
        </c:ser>
        <c:ser>
          <c:idx val="3"/>
          <c:order val="3"/>
          <c:tx>
            <c:strRef>
              <c:f>アンケート!$F$3</c:f>
              <c:strCache>
                <c:ptCount val="1"/>
                <c:pt idx="0">
                  <c:v>Disagreed somewhat</c:v>
                </c:pt>
              </c:strCache>
            </c:strRef>
          </c:tx>
          <c:invertIfNegative val="0"/>
          <c:cat>
            <c:strRef>
              <c:f>アンケート!$B$4:$B$11</c:f>
              <c:strCache>
                <c:ptCount val="8"/>
                <c:pt idx="0">
                  <c:v>Want to continue using them</c:v>
                </c:pt>
                <c:pt idx="1">
                  <c:v>Benefit me</c:v>
                </c:pt>
                <c:pt idx="2">
                  <c:v>Affected area becomes inconspicuous</c:v>
                </c:pt>
                <c:pt idx="3">
                  <c:v>Formed color lasts</c:v>
                </c:pt>
                <c:pt idx="4">
                  <c:v>Skin color changes gradually</c:v>
                </c:pt>
                <c:pt idx="5">
                  <c:v>Free from load on the skin</c:v>
                </c:pt>
                <c:pt idx="6">
                  <c:v>Compatible with the skin</c:v>
                </c:pt>
                <c:pt idx="7">
                  <c:v>Soft to the touch</c:v>
                </c:pt>
              </c:strCache>
            </c:strRef>
          </c:cat>
          <c:val>
            <c:numRef>
              <c:f>アンケート!$F$4:$F$11</c:f>
              <c:numCache>
                <c:formatCode>General</c:formatCode>
                <c:ptCount val="8"/>
                <c:pt idx="2">
                  <c:v>1</c:v>
                </c:pt>
                <c:pt idx="3">
                  <c:v>1</c:v>
                </c:pt>
                <c:pt idx="4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4EB-447E-8904-F0E07FEC51A0}"/>
            </c:ext>
          </c:extLst>
        </c:ser>
        <c:ser>
          <c:idx val="4"/>
          <c:order val="4"/>
          <c:tx>
            <c:strRef>
              <c:f>アンケート!$G$3</c:f>
              <c:strCache>
                <c:ptCount val="1"/>
                <c:pt idx="0">
                  <c:v>Disagreed</c:v>
                </c:pt>
              </c:strCache>
            </c:strRef>
          </c:tx>
          <c:invertIfNegative val="0"/>
          <c:cat>
            <c:strRef>
              <c:f>アンケート!$B$4:$B$11</c:f>
              <c:strCache>
                <c:ptCount val="8"/>
                <c:pt idx="0">
                  <c:v>Want to continue using them</c:v>
                </c:pt>
                <c:pt idx="1">
                  <c:v>Benefit me</c:v>
                </c:pt>
                <c:pt idx="2">
                  <c:v>Affected area becomes inconspicuous</c:v>
                </c:pt>
                <c:pt idx="3">
                  <c:v>Formed color lasts</c:v>
                </c:pt>
                <c:pt idx="4">
                  <c:v>Skin color changes gradually</c:v>
                </c:pt>
                <c:pt idx="5">
                  <c:v>Free from load on the skin</c:v>
                </c:pt>
                <c:pt idx="6">
                  <c:v>Compatible with the skin</c:v>
                </c:pt>
                <c:pt idx="7">
                  <c:v>Soft to the touch</c:v>
                </c:pt>
              </c:strCache>
            </c:strRef>
          </c:cat>
          <c:val>
            <c:numRef>
              <c:f>アンケート!$G$4:$G$11</c:f>
              <c:numCache>
                <c:formatCode>General</c:formatCode>
                <c:ptCount val="8"/>
              </c:numCache>
            </c:numRef>
          </c:val>
          <c:extLst>
            <c:ext xmlns:c16="http://schemas.microsoft.com/office/drawing/2014/chart" uri="{C3380CC4-5D6E-409C-BE32-E72D297353CC}">
              <c16:uniqueId val="{00000004-54EB-447E-8904-F0E07FEC51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65349120"/>
        <c:axId val="65351040"/>
      </c:barChart>
      <c:catAx>
        <c:axId val="65349120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65351040"/>
        <c:crosses val="autoZero"/>
        <c:auto val="1"/>
        <c:lblAlgn val="ctr"/>
        <c:lblOffset val="100"/>
        <c:noMultiLvlLbl val="0"/>
      </c:catAx>
      <c:valAx>
        <c:axId val="65351040"/>
        <c:scaling>
          <c:orientation val="minMax"/>
        </c:scaling>
        <c:delete val="0"/>
        <c:axPos val="b"/>
        <c:majorGridlines/>
        <c:numFmt formatCode="0%" sourceLinked="1"/>
        <c:majorTickMark val="out"/>
        <c:minorTickMark val="none"/>
        <c:tickLblPos val="nextTo"/>
        <c:txPr>
          <a:bodyPr/>
          <a:lstStyle/>
          <a:p>
            <a:pPr>
              <a:defRPr sz="11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defRPr>
            </a:pPr>
            <a:endParaRPr lang="ja-JP"/>
          </a:p>
        </c:txPr>
        <c:crossAx val="65349120"/>
        <c:crosses val="autoZero"/>
        <c:crossBetween val="between"/>
        <c:majorUnit val="0.2"/>
      </c:valAx>
    </c:plotArea>
    <c:legend>
      <c:legendPos val="r"/>
      <c:overlay val="0"/>
      <c:txPr>
        <a:bodyPr/>
        <a:lstStyle/>
        <a:p>
          <a:pPr>
            <a:defRPr sz="1200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defRPr>
          </a:pPr>
          <a:endParaRPr lang="ja-JP"/>
        </a:p>
      </c:txPr>
    </c:legend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F0525D-2DEE-4A62-81F7-B9072CD59496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55E0A2D-FB0D-45D0-91A6-2A6B6D07B194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109691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7"/>
          <p:cNvSpPr>
            <a:spLocks noGrp="1" noChangeArrowheads="1"/>
          </p:cNvSpPr>
          <p:nvPr>
            <p:ph type="sldNum" sz="quarter" idx="5"/>
          </p:nvPr>
        </p:nvSpPr>
        <p:spPr>
          <a:noFill/>
        </p:spPr>
        <p:txBody>
          <a:bodyPr/>
          <a:lstStyle>
            <a:lvl1pPr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1pPr>
            <a:lvl2pPr marL="742950" indent="-28575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2pPr>
            <a:lvl3pPr marL="1143000" indent="-22860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3pPr>
            <a:lvl4pPr marL="1600200" indent="-22860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4pPr>
            <a:lvl5pPr marL="2057400" indent="-228600" eaLnBrk="0" hangingPunct="0"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 baseline="30000">
                <a:solidFill>
                  <a:schemeClr val="tx1"/>
                </a:solidFill>
                <a:latin typeface="Helvetica" charset="0"/>
                <a:ea typeface="Osaka" charset="-128"/>
              </a:defRPr>
            </a:lvl9pPr>
          </a:lstStyle>
          <a:p>
            <a:pPr eaLnBrk="1" hangingPunct="1"/>
            <a:fld id="{5E79BB76-7753-49C0-AADB-93440A76BAE3}" type="slidenum">
              <a:rPr lang="en-US" altLang="ja-JP" sz="1200" baseline="0">
                <a:latin typeface="Times" charset="0"/>
              </a:rPr>
              <a:pPr eaLnBrk="1" hangingPunct="1"/>
              <a:t>1</a:t>
            </a:fld>
            <a:endParaRPr lang="en-US" altLang="ja-JP" sz="1200" baseline="0">
              <a:latin typeface="Times" charset="0"/>
            </a:endParaRPr>
          </a:p>
        </p:txBody>
      </p:sp>
      <p:sp>
        <p:nvSpPr>
          <p:cNvPr id="10243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0244" name="Rectangle 3"/>
          <p:cNvSpPr>
            <a:spLocks noGrp="1" noChangeArrowheads="1"/>
          </p:cNvSpPr>
          <p:nvPr>
            <p:ph type="body" idx="1"/>
          </p:nvPr>
        </p:nvSpPr>
        <p:spPr>
          <a:noFill/>
        </p:spPr>
        <p:txBody>
          <a:bodyPr/>
          <a:lstStyle/>
          <a:p>
            <a:pPr eaLnBrk="1" hangingPunct="1"/>
            <a:endParaRPr lang="ja-JP" altLang="ja-JP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C21DCC-0B02-47BF-BACC-0717C9AE6BF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65CCCB9-70EC-4BEC-A0B6-BCB41AEC83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F199ED-7959-4D0C-B77A-87E2F9F225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C9D47C-38CE-4244-B6EC-2F24EA37D5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C66348-8936-4EB4-B9AB-F27D75658A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48784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E57C99-903B-4D83-B230-B71F2A2A86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48748B5-A02F-4E5F-A939-65D8A9DA30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276998-1296-483A-B7A8-D8C8C9DD47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FEC3DC-6A6D-4FA2-B1A4-11076F98E5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896D5E-1787-4DEE-9552-7E5FE1C507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58860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588D170-A0C3-4E3F-BD11-2843B2F076A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5B490D-4DF4-4302-819F-159781C474D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90F94C-26A7-4717-8C90-B01F66B2B8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493E45-8927-457D-A286-5191F7B09C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DD1CE-8FC2-430E-ADDD-5872F47EB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40145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3BA2DE-3D3D-4875-984D-7C6EDC2E03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6299907-4EF4-480B-9457-5473AE1E13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27509E-D748-4D79-98E7-6FBE3D6A3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004B0A-159A-4B19-907F-9B9957425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FC31FEC-878F-41E8-B5D3-3322A388B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08371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05EBB4-0D96-4AB4-9196-A0AF28D9B5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CD4C67-BDD1-488D-AB2F-1115EC0CB2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F59EE-5E0C-46AC-A52B-00F7BA7133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266106-28FD-4AFA-852E-ED15B2442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800524-21EA-428D-9216-AC72D8F64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5026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BAD1CC-09DF-4500-83C2-A42E713413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F9BBF6-E794-4871-B461-BD0F34C318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158838-A9C1-48BE-8FA6-ACE256FF2D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E82B40-2BBC-4C85-A187-AA2174CAC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A9D5A6-70AF-487F-A429-35BAA40DE4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B15554-FDF8-4F80-9459-8FADC33BC3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02426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49D690-3AB9-4820-8207-5D30C0BD4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91674B-0005-4BAB-A0A7-A48EDE62D8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2653E8-D35B-4EAF-B1A1-712A118291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24E722-82F9-455D-8DF0-D02AA37995D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D31918-FBAA-4D88-B32E-F43C58F396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65D981E-9712-4164-BDC5-EE8AAA530F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3C1D601-F402-4A15-9F32-9DB11D567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FAD122E-AE29-4D26-80B4-CB1D61FD5C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81922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7327B0-C2C7-4B2E-91BD-87CF5A22A5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1FC3CF-843A-4DAC-851D-40901BA767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36A896D-60EB-49B5-A1B8-8334EA7513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BA1F9E-AFA7-4478-B27E-24070D6545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79047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A775252-221A-46D5-9FAF-3BDF480060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D29517-532B-45F7-99E5-3376B3FD02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E20DC24-3021-43F1-9F32-E57631826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114853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E80C8E-A01B-491A-AAFB-564EA21192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29D51E-E34F-4B49-8918-CD45ADF919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74E42E-D8D0-4C52-8935-FD51FB07E4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894E26-4173-4034-A23A-85AF8267A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645CCF-C741-4D68-A4D1-1D34502BEA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DAD0D0-2DAC-401C-9861-7E4F5F603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647641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F92DC0-813E-4744-ACCA-1080DCBBFC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FBF510-4DB1-4C90-AD4B-035C8ACE7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18A3DB2-1ED8-4031-BAB4-3315AE520B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59F2D7-84A7-4A22-9DFA-DC3B73B16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68152B-85CA-4CFC-AF2D-3C84AC9237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0CDEA5-B530-471D-901D-81FE9866C6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59941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1BE6B9A-779B-4A13-9D3E-D1524B0321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402F85-1001-4F89-A0A1-DB5746BDD7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A0CB9D-566C-46EE-8DB1-F15427D8D02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B8E0A4-7C9E-4BAC-8802-9D1B228F755C}" type="datetimeFigureOut">
              <a:rPr lang="en-IN" smtClean="0"/>
              <a:t>30-03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A1BEDE-EECE-4278-995C-D6798DF4140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020FC3-F7B5-4C92-A416-9CD3200E7C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1C013-5B51-4313-ADE9-E57B32579B27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74553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5848482"/>
              </p:ext>
            </p:extLst>
          </p:nvPr>
        </p:nvGraphicFramePr>
        <p:xfrm>
          <a:off x="1991130" y="1537294"/>
          <a:ext cx="8319600" cy="352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124" name="Text Box 27"/>
          <p:cNvSpPr txBox="1">
            <a:spLocks noChangeAspect="1" noChangeArrowheads="1"/>
          </p:cNvSpPr>
          <p:nvPr/>
        </p:nvSpPr>
        <p:spPr bwMode="auto">
          <a:xfrm>
            <a:off x="9715500" y="25400"/>
            <a:ext cx="1361982" cy="4044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lIns="95761" tIns="47880" rIns="95761" bIns="47880">
            <a:spAutoFit/>
          </a:bodyPr>
          <a:lstStyle>
            <a:lvl1pPr defTabSz="958850" eaLnBrk="0" hangingPunct="0">
              <a:spcBef>
                <a:spcPct val="20000"/>
              </a:spcBef>
              <a:buChar char="•"/>
              <a:defRPr kumimoji="1" sz="3400">
                <a:solidFill>
                  <a:schemeClr val="tx1"/>
                </a:solidFill>
                <a:latin typeface="Times" charset="0"/>
                <a:ea typeface="Osaka" charset="-128"/>
              </a:defRPr>
            </a:lvl1pPr>
            <a:lvl2pPr marL="477838" indent="-300038" defTabSz="958850" eaLnBrk="0" hangingPunct="0">
              <a:spcBef>
                <a:spcPct val="20000"/>
              </a:spcBef>
              <a:buChar char="–"/>
              <a:defRPr kumimoji="1" sz="2900">
                <a:solidFill>
                  <a:schemeClr val="tx1"/>
                </a:solidFill>
                <a:latin typeface="Times" charset="0"/>
                <a:ea typeface="Osaka" charset="-128"/>
              </a:defRPr>
            </a:lvl2pPr>
            <a:lvl3pPr marL="958850" indent="-238125" defTabSz="958850" eaLnBrk="0" hangingPunct="0">
              <a:spcBef>
                <a:spcPct val="20000"/>
              </a:spcBef>
              <a:buChar char="•"/>
              <a:defRPr kumimoji="1" sz="2500">
                <a:solidFill>
                  <a:schemeClr val="tx1"/>
                </a:solidFill>
                <a:latin typeface="Times" charset="0"/>
                <a:ea typeface="Osaka" charset="-128"/>
              </a:defRPr>
            </a:lvl3pPr>
            <a:lvl4pPr marL="1436688" indent="-239713" defTabSz="958850" eaLnBrk="0" hangingPunct="0">
              <a:spcBef>
                <a:spcPct val="20000"/>
              </a:spcBef>
              <a:buChar char="–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4pPr>
            <a:lvl5pPr marL="1916113" indent="-239713" defTabSz="958850" eaLnBrk="0" hangingPunct="0">
              <a:spcBef>
                <a:spcPct val="20000"/>
              </a:spcBef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5pPr>
            <a:lvl6pPr marL="23733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6pPr>
            <a:lvl7pPr marL="28305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7pPr>
            <a:lvl8pPr marL="32877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8pPr>
            <a:lvl9pPr marL="3744913" indent="-239713" defTabSz="95885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100">
                <a:solidFill>
                  <a:schemeClr val="tx1"/>
                </a:solidFill>
                <a:latin typeface="Times" charset="0"/>
                <a:ea typeface="Osaka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2000" b="1">
                <a:latin typeface="Helvetica" charset="0"/>
              </a:rPr>
              <a:t>Figure S2</a:t>
            </a:r>
            <a:endParaRPr lang="en-US" altLang="ja-JP" sz="2000" b="1" dirty="0">
              <a:latin typeface="Helvetica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69572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D4B9EBA92216F3458B5C84281E4EE42F" ma:contentTypeVersion="13" ma:contentTypeDescription="新しいドキュメントを作成します。" ma:contentTypeScope="" ma:versionID="a7f8ceb76a5029ef598233489bac6ba5">
  <xsd:schema xmlns:xsd="http://www.w3.org/2001/XMLSchema" xmlns:xs="http://www.w3.org/2001/XMLSchema" xmlns:p="http://schemas.microsoft.com/office/2006/metadata/properties" xmlns:ns3="322596d5-e965-453b-a2f0-e4f7fe72565a" xmlns:ns4="a730ae63-93a0-4ae2-9e86-392e8a01305f" targetNamespace="http://schemas.microsoft.com/office/2006/metadata/properties" ma:root="true" ma:fieldsID="2cb02059cca2e62e92c53e6045c9882b" ns3:_="" ns4:_="">
    <xsd:import namespace="322596d5-e965-453b-a2f0-e4f7fe72565a"/>
    <xsd:import namespace="a730ae63-93a0-4ae2-9e86-392e8a01305f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DateTaken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22596d5-e965-453b-a2f0-e4f7fe72565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4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730ae63-93a0-4ae2-9e86-392e8a01305f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共有相手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共有相手の詳細情報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共有のヒントのハッシュ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A18C93E9-588D-4A84-95F7-F7702F3077B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22596d5-e965-453b-a2f0-e4f7fe72565a"/>
    <ds:schemaRef ds:uri="a730ae63-93a0-4ae2-9e86-392e8a01305f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2F1443A-29AB-4821-A228-86EC30E611FF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5232E9D-D40A-4FBC-BF40-AF4568A73A71}">
  <ds:schemaRefs>
    <ds:schemaRef ds:uri="http://schemas.microsoft.com/office/2006/documentManagement/types"/>
    <ds:schemaRef ds:uri="http://purl.org/dc/elements/1.1/"/>
    <ds:schemaRef ds:uri="322596d5-e965-453b-a2f0-e4f7fe72565a"/>
    <ds:schemaRef ds:uri="a730ae63-93a0-4ae2-9e86-392e8a01305f"/>
    <ds:schemaRef ds:uri="http://schemas.microsoft.com/office/infopath/2007/PartnerControls"/>
    <ds:schemaRef ds:uri="http://schemas.openxmlformats.org/package/2006/metadata/core-properties"/>
    <ds:schemaRef ds:uri="http://schemas.microsoft.com/office/2006/metadata/properties"/>
    <ds:schemaRef ds:uri="http://www.w3.org/XML/1998/namespace"/>
    <ds:schemaRef ds:uri="http://purl.org/dc/dcmitype/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3</Words>
  <Application>Microsoft Office PowerPoint</Application>
  <PresentationFormat>ワイド画面</PresentationFormat>
  <Paragraphs>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Osaka</vt:lpstr>
      <vt:lpstr>游ゴシック</vt:lpstr>
      <vt:lpstr>Arial</vt:lpstr>
      <vt:lpstr>Calibri</vt:lpstr>
      <vt:lpstr>Calibri Light</vt:lpstr>
      <vt:lpstr>Helvetica</vt:lpstr>
      <vt:lpstr>Times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Takahashi Yoshito (高橋 慶人)</cp:lastModifiedBy>
  <cp:revision>2</cp:revision>
  <dcterms:created xsi:type="dcterms:W3CDTF">2019-12-19T16:47:35Z</dcterms:created>
  <dcterms:modified xsi:type="dcterms:W3CDTF">2020-03-29T19:39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4B9EBA92216F3458B5C84281E4EE42F</vt:lpwstr>
  </property>
</Properties>
</file>